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20"/>
  </p:notesMasterIdLst>
  <p:sldIdLst>
    <p:sldId id="256" r:id="rId2"/>
    <p:sldId id="281" r:id="rId3"/>
    <p:sldId id="282" r:id="rId4"/>
    <p:sldId id="283" r:id="rId5"/>
    <p:sldId id="284" r:id="rId6"/>
    <p:sldId id="285" r:id="rId7"/>
    <p:sldId id="286" r:id="rId8"/>
    <p:sldId id="287" r:id="rId9"/>
    <p:sldId id="288" r:id="rId10"/>
    <p:sldId id="258" r:id="rId11"/>
    <p:sldId id="257" r:id="rId12"/>
    <p:sldId id="259" r:id="rId13"/>
    <p:sldId id="262" r:id="rId14"/>
    <p:sldId id="260" r:id="rId15"/>
    <p:sldId id="261" r:id="rId16"/>
    <p:sldId id="264" r:id="rId17"/>
    <p:sldId id="279" r:id="rId18"/>
    <p:sldId id="280" r:id="rId19"/>
  </p:sldIdLst>
  <p:sldSz cx="9144000" cy="5143500" type="screen16x9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FB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BD1F4AA-5B40-973B-9C1D-17A4F5BD2B5A}" v="1451" dt="2025-09-09T01:10:52.902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88704"/>
  </p:normalViewPr>
  <p:slideViewPr>
    <p:cSldViewPr snapToGrid="0">
      <p:cViewPr varScale="1">
        <p:scale>
          <a:sx n="121" d="100"/>
          <a:sy n="121" d="100"/>
        </p:scale>
        <p:origin x="1464" y="18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g2aa8199f5c0_0_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3" name="Google Shape;63;g2aa8199f5c0_0_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2aa8199f5c0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2aa8199f5c0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g2aa8199f5c0_0_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8" name="Google Shape;68;g2aa8199f5c0_0_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Google Shape;82;g2aa8199f5c0_0_2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3" name="Google Shape;83;g2aa8199f5c0_0_2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Google Shape;72;g2aa8199f5c0_0_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3" name="Google Shape;73;g2aa8199f5c0_0_1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g2aa8199f5c0_0_2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78" name="Google Shape;78;g2aa8199f5c0_0_2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g2aa8199f5c0_0_3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5" name="Google Shape;95;g2aa8199f5c0_0_3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g2aa8199f5c0_0_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8" name="Google Shape;68;g2aa8199f5c0_0_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  <p:extLst>
      <p:ext uri="{BB962C8B-B14F-4D97-AF65-F5344CB8AC3E}">
        <p14:creationId xmlns:p14="http://schemas.microsoft.com/office/powerpoint/2010/main" val="23644025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5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5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5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5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5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5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5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5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Labs, Imaging, Prompts</a:t>
            </a:r>
            <a:endParaRPr dirty="0"/>
          </a:p>
        </p:txBody>
      </p:sp>
      <p:sp>
        <p:nvSpPr>
          <p:cNvPr id="55" name="Google Shape;55;p13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Google Shape;65;p1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r>
              <a:rPr lang="en" dirty="0"/>
              <a:t>Point of Care (POC)- Glucose</a:t>
            </a:r>
            <a:endParaRPr dirty="0"/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512B883-AE31-1B2B-38B8-F94EE355D50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3123663"/>
              </p:ext>
            </p:extLst>
          </p:nvPr>
        </p:nvGraphicFramePr>
        <p:xfrm>
          <a:off x="830509" y="1736521"/>
          <a:ext cx="5931018" cy="96473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422528">
                  <a:extLst>
                    <a:ext uri="{9D8B030D-6E8A-4147-A177-3AD203B41FA5}">
                      <a16:colId xmlns:a16="http://schemas.microsoft.com/office/drawing/2014/main" val="614482929"/>
                    </a:ext>
                  </a:extLst>
                </a:gridCol>
                <a:gridCol w="1754245">
                  <a:extLst>
                    <a:ext uri="{9D8B030D-6E8A-4147-A177-3AD203B41FA5}">
                      <a16:colId xmlns:a16="http://schemas.microsoft.com/office/drawing/2014/main" val="3568972541"/>
                    </a:ext>
                  </a:extLst>
                </a:gridCol>
                <a:gridCol w="1754245">
                  <a:extLst>
                    <a:ext uri="{9D8B030D-6E8A-4147-A177-3AD203B41FA5}">
                      <a16:colId xmlns:a16="http://schemas.microsoft.com/office/drawing/2014/main" val="309096339"/>
                    </a:ext>
                  </a:extLst>
                </a:gridCol>
              </a:tblGrid>
              <a:tr h="4823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highlight>
                            <a:srgbClr val="B4C6E7"/>
                          </a:highlight>
                        </a:rPr>
                        <a:t>Laboratory Test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highlight>
                            <a:srgbClr val="B4C6E7"/>
                          </a:highlight>
                        </a:rPr>
                        <a:t>Valu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highlight>
                            <a:srgbClr val="B4C6E7"/>
                          </a:highlight>
                        </a:rPr>
                        <a:t>Unit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93360677"/>
                  </a:ext>
                </a:extLst>
              </a:tr>
              <a:tr h="4823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OC-Gluco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1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err="1">
                          <a:effectLst/>
                        </a:rPr>
                        <a:t>mEq</a:t>
                      </a:r>
                      <a:r>
                        <a:rPr lang="en-US" sz="1200" u="none" strike="noStrike">
                          <a:effectLst/>
                        </a:rPr>
                        <a:t>/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66974529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Venous Blood Gas</a:t>
            </a:r>
            <a:endParaRPr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D2F2D99-A295-6E25-279B-D81BFFBBC73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5299552"/>
              </p:ext>
            </p:extLst>
          </p:nvPr>
        </p:nvGraphicFramePr>
        <p:xfrm>
          <a:off x="1577130" y="1610686"/>
          <a:ext cx="4347421" cy="184152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75707">
                  <a:extLst>
                    <a:ext uri="{9D8B030D-6E8A-4147-A177-3AD203B41FA5}">
                      <a16:colId xmlns:a16="http://schemas.microsoft.com/office/drawing/2014/main" val="2388810572"/>
                    </a:ext>
                  </a:extLst>
                </a:gridCol>
                <a:gridCol w="1285857">
                  <a:extLst>
                    <a:ext uri="{9D8B030D-6E8A-4147-A177-3AD203B41FA5}">
                      <a16:colId xmlns:a16="http://schemas.microsoft.com/office/drawing/2014/main" val="2808337591"/>
                    </a:ext>
                  </a:extLst>
                </a:gridCol>
                <a:gridCol w="1285857">
                  <a:extLst>
                    <a:ext uri="{9D8B030D-6E8A-4147-A177-3AD203B41FA5}">
                      <a16:colId xmlns:a16="http://schemas.microsoft.com/office/drawing/2014/main" val="818530024"/>
                    </a:ext>
                  </a:extLst>
                </a:gridCol>
              </a:tblGrid>
              <a:tr h="3356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Laboratory Tes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Unit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43246792"/>
                  </a:ext>
                </a:extLst>
              </a:tr>
              <a:tr h="2517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pH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7.3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mmH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66074242"/>
                  </a:ext>
                </a:extLst>
              </a:tr>
              <a:tr h="2517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Partial pressure of carbon dioxide</a:t>
                      </a: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4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mmH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26313337"/>
                  </a:ext>
                </a:extLst>
              </a:tr>
              <a:tr h="251760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200" u="none" strike="noStrike">
                          <a:effectLst/>
                        </a:rPr>
                        <a:t>Partial pressure of oxygen</a:t>
                      </a:r>
                      <a:endParaRPr lang="en-US" sz="1200" u="none" strike="noStrike" dirty="0">
                        <a:effectLst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3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917276"/>
                  </a:ext>
                </a:extLst>
              </a:tr>
              <a:tr h="2517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bicarbona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2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80784235"/>
                  </a:ext>
                </a:extLst>
              </a:tr>
              <a:tr h="2517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Base Exces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0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871296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Google Shape;70;p1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Complete Blood Count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AF89AA36-263A-BB4F-B93B-ED1663EBC0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6150389"/>
              </p:ext>
            </p:extLst>
          </p:nvPr>
        </p:nvGraphicFramePr>
        <p:xfrm>
          <a:off x="1113812" y="1654287"/>
          <a:ext cx="5177931" cy="233327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88111">
                  <a:extLst>
                    <a:ext uri="{9D8B030D-6E8A-4147-A177-3AD203B41FA5}">
                      <a16:colId xmlns:a16="http://schemas.microsoft.com/office/drawing/2014/main" val="2254030423"/>
                    </a:ext>
                  </a:extLst>
                </a:gridCol>
                <a:gridCol w="1828800">
                  <a:extLst>
                    <a:ext uri="{9D8B030D-6E8A-4147-A177-3AD203B41FA5}">
                      <a16:colId xmlns:a16="http://schemas.microsoft.com/office/drawing/2014/main" val="1417602540"/>
                    </a:ext>
                  </a:extLst>
                </a:gridCol>
                <a:gridCol w="1661020">
                  <a:extLst>
                    <a:ext uri="{9D8B030D-6E8A-4147-A177-3AD203B41FA5}">
                      <a16:colId xmlns:a16="http://schemas.microsoft.com/office/drawing/2014/main" val="3595192226"/>
                    </a:ext>
                  </a:extLst>
                </a:gridCol>
              </a:tblGrid>
              <a:tr h="3263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Laboratory Tes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Unit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83913766"/>
                  </a:ext>
                </a:extLst>
              </a:tr>
              <a:tr h="3263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White Blood Cell Cou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51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/mm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52203584"/>
                  </a:ext>
                </a:extLst>
              </a:tr>
              <a:tr h="3263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Hemoglob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6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g/d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46625066"/>
                  </a:ext>
                </a:extLst>
              </a:tr>
              <a:tr h="3263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Hematocri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68401820"/>
                  </a:ext>
                </a:extLst>
              </a:tr>
              <a:tr h="3263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Platelet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/mm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5462384"/>
                  </a:ext>
                </a:extLst>
              </a:tr>
              <a:tr h="3263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Mean Corpuscular Volum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8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fL</a:t>
                      </a:r>
                      <a:r>
                        <a:rPr lang="en-US" sz="1200" u="none" strike="noStrike" dirty="0">
                          <a:effectLst/>
                        </a:rPr>
                        <a:t>/re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99330403"/>
                  </a:ext>
                </a:extLst>
              </a:tr>
              <a:tr h="3263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Blasts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6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06592224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D476A6C3-5079-D876-4801-3471CD53E1A7}"/>
              </a:ext>
            </a:extLst>
          </p:cNvPr>
          <p:cNvSpPr txBox="1"/>
          <p:nvPr/>
        </p:nvSpPr>
        <p:spPr>
          <a:xfrm>
            <a:off x="1113812" y="4558070"/>
            <a:ext cx="47724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Peripheral blood smear with schistocytes and helmet cells</a:t>
            </a: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9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Coagulation Labs</a:t>
            </a:r>
            <a:endParaRPr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0F4465F-4521-9DF5-DE15-56DECBABFBB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2138568"/>
              </p:ext>
            </p:extLst>
          </p:nvPr>
        </p:nvGraphicFramePr>
        <p:xfrm>
          <a:off x="1031845" y="2071686"/>
          <a:ext cx="6837027" cy="202702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155152">
                  <a:extLst>
                    <a:ext uri="{9D8B030D-6E8A-4147-A177-3AD203B41FA5}">
                      <a16:colId xmlns:a16="http://schemas.microsoft.com/office/drawing/2014/main" val="3903660688"/>
                    </a:ext>
                  </a:extLst>
                </a:gridCol>
                <a:gridCol w="1560625">
                  <a:extLst>
                    <a:ext uri="{9D8B030D-6E8A-4147-A177-3AD203B41FA5}">
                      <a16:colId xmlns:a16="http://schemas.microsoft.com/office/drawing/2014/main" val="1277735677"/>
                    </a:ext>
                  </a:extLst>
                </a:gridCol>
                <a:gridCol w="1560625">
                  <a:extLst>
                    <a:ext uri="{9D8B030D-6E8A-4147-A177-3AD203B41FA5}">
                      <a16:colId xmlns:a16="http://schemas.microsoft.com/office/drawing/2014/main" val="1641810628"/>
                    </a:ext>
                  </a:extLst>
                </a:gridCol>
                <a:gridCol w="1560625">
                  <a:extLst>
                    <a:ext uri="{9D8B030D-6E8A-4147-A177-3AD203B41FA5}">
                      <a16:colId xmlns:a16="http://schemas.microsoft.com/office/drawing/2014/main" val="1542869525"/>
                    </a:ext>
                  </a:extLst>
                </a:gridCol>
              </a:tblGrid>
              <a:tr h="3200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highlight>
                            <a:srgbClr val="B4C6E7"/>
                          </a:highlight>
                        </a:rPr>
                        <a:t>Laboratory Tes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highlight>
                            <a:srgbClr val="B4C6E7"/>
                          </a:highlight>
                        </a:rPr>
                        <a:t>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effectLst/>
                          <a:highlight>
                            <a:srgbClr val="B4C6E7"/>
                          </a:highlight>
                        </a:rPr>
                        <a:t>Unit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highlight>
                            <a:srgbClr val="B4C6E7"/>
                          </a:highlight>
                          <a:latin typeface="Calibri"/>
                        </a:rPr>
                        <a:t>Reference Range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74430631"/>
                  </a:ext>
                </a:extLst>
              </a:tr>
              <a:tr h="3200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effectLst/>
                        </a:rPr>
                        <a:t>Prothromin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23.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se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-15.3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14088712"/>
                  </a:ext>
                </a:extLst>
              </a:tr>
              <a:tr h="320070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200" b="1" u="none" strike="noStrike">
                          <a:effectLst/>
                        </a:rPr>
                        <a:t>Partial thromboblastin time</a:t>
                      </a:r>
                      <a:endParaRPr lang="en-US"/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42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sec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-38.8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78666464"/>
                  </a:ext>
                </a:extLst>
              </a:tr>
              <a:tr h="320070">
                <a:tc>
                  <a:txBody>
                    <a:bodyPr/>
                    <a:lstStyle/>
                    <a:p>
                      <a:pPr lvl="0" algn="ctr">
                        <a:buNone/>
                      </a:pPr>
                      <a:r>
                        <a:rPr lang="en-US" sz="1200" b="1" u="none" strike="noStrike">
                          <a:effectLst/>
                        </a:rPr>
                        <a:t>International Normalized Ratio</a:t>
                      </a:r>
                      <a:endParaRPr lang="en-US"/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1.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-1.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19625988"/>
                  </a:ext>
                </a:extLst>
              </a:tr>
              <a:tr h="37145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D-dime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7.79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>
                          <a:effectLst/>
                        </a:rPr>
                        <a:t> mcg/m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-0.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81197664"/>
                  </a:ext>
                </a:extLst>
              </a:tr>
              <a:tr h="3200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ibrinogen</a:t>
                      </a: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&lt;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g/L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-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03562994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7"/>
          <p:cNvSpPr txBox="1">
            <a:spLocks noGrp="1"/>
          </p:cNvSpPr>
          <p:nvPr>
            <p:ph type="title"/>
          </p:nvPr>
        </p:nvSpPr>
        <p:spPr>
          <a:xfrm>
            <a:off x="241019" y="151410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Comprehensive Metabolic Profile</a:t>
            </a:r>
            <a:endParaRPr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EE9C8B2-28DD-4642-C7AB-9B6B1B3DE4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1006609"/>
              </p:ext>
            </p:extLst>
          </p:nvPr>
        </p:nvGraphicFramePr>
        <p:xfrm>
          <a:off x="2144027" y="724110"/>
          <a:ext cx="4345468" cy="397092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38576">
                  <a:extLst>
                    <a:ext uri="{9D8B030D-6E8A-4147-A177-3AD203B41FA5}">
                      <a16:colId xmlns:a16="http://schemas.microsoft.com/office/drawing/2014/main" val="1769827520"/>
                    </a:ext>
                  </a:extLst>
                </a:gridCol>
                <a:gridCol w="1370940">
                  <a:extLst>
                    <a:ext uri="{9D8B030D-6E8A-4147-A177-3AD203B41FA5}">
                      <a16:colId xmlns:a16="http://schemas.microsoft.com/office/drawing/2014/main" val="3757846763"/>
                    </a:ext>
                  </a:extLst>
                </a:gridCol>
                <a:gridCol w="1135952">
                  <a:extLst>
                    <a:ext uri="{9D8B030D-6E8A-4147-A177-3AD203B41FA5}">
                      <a16:colId xmlns:a16="http://schemas.microsoft.com/office/drawing/2014/main" val="726549189"/>
                    </a:ext>
                  </a:extLst>
                </a:gridCol>
              </a:tblGrid>
              <a:tr h="33250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Laboratory Tes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Unit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58912849"/>
                  </a:ext>
                </a:extLst>
              </a:tr>
              <a:tr h="2493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Sodiu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4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18626887"/>
                  </a:ext>
                </a:extLst>
              </a:tr>
              <a:tr h="23757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Potassiu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95544149"/>
                  </a:ext>
                </a:extLst>
              </a:tr>
              <a:tr h="2493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Chlori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83024514"/>
                  </a:ext>
                </a:extLst>
              </a:tr>
              <a:tr h="2493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Bicarbona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21668105"/>
                  </a:ext>
                </a:extLst>
              </a:tr>
              <a:tr h="2493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Blood urea nitroge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18776917"/>
                  </a:ext>
                </a:extLst>
              </a:tr>
              <a:tr h="2493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Creatin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47122930"/>
                  </a:ext>
                </a:extLst>
              </a:tr>
              <a:tr h="2493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Gluco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3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11741758"/>
                  </a:ext>
                </a:extLst>
              </a:tr>
              <a:tr h="2493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Prote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7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g/d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78821447"/>
                  </a:ext>
                </a:extLst>
              </a:tr>
              <a:tr h="2493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Album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g/d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67845300"/>
                  </a:ext>
                </a:extLst>
              </a:tr>
              <a:tr h="2493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Total Bilirub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mg/d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1494583"/>
                  </a:ext>
                </a:extLst>
              </a:tr>
              <a:tr h="2493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Aspartate Aminotransfera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5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U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22235217"/>
                  </a:ext>
                </a:extLst>
              </a:tr>
              <a:tr h="2493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Alanine Aminotransfera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5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U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95555695"/>
                  </a:ext>
                </a:extLst>
              </a:tr>
              <a:tr h="28237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Alkaline Phosphata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U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63185481"/>
                  </a:ext>
                </a:extLst>
              </a:tr>
              <a:tr h="2493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Uric Aci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mg/d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5590043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Google Shape;80;p18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Inflammatory Markers</a:t>
            </a:r>
            <a:endParaRPr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790FE5A-E6E4-398E-7BD3-FCF89DD531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0822194"/>
              </p:ext>
            </p:extLst>
          </p:nvPr>
        </p:nvGraphicFramePr>
        <p:xfrm>
          <a:off x="1778466" y="1291905"/>
          <a:ext cx="4323883" cy="279353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33850">
                  <a:extLst>
                    <a:ext uri="{9D8B030D-6E8A-4147-A177-3AD203B41FA5}">
                      <a16:colId xmlns:a16="http://schemas.microsoft.com/office/drawing/2014/main" val="4009041242"/>
                    </a:ext>
                  </a:extLst>
                </a:gridCol>
                <a:gridCol w="1859723">
                  <a:extLst>
                    <a:ext uri="{9D8B030D-6E8A-4147-A177-3AD203B41FA5}">
                      <a16:colId xmlns:a16="http://schemas.microsoft.com/office/drawing/2014/main" val="2678989061"/>
                    </a:ext>
                  </a:extLst>
                </a:gridCol>
                <a:gridCol w="1130310">
                  <a:extLst>
                    <a:ext uri="{9D8B030D-6E8A-4147-A177-3AD203B41FA5}">
                      <a16:colId xmlns:a16="http://schemas.microsoft.com/office/drawing/2014/main" val="1995606984"/>
                    </a:ext>
                  </a:extLst>
                </a:gridCol>
              </a:tblGrid>
              <a:tr h="4655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Laboratory Tes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Unit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40566609"/>
                  </a:ext>
                </a:extLst>
              </a:tr>
              <a:tr h="4655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Procalcitoni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1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288359"/>
                  </a:ext>
                </a:extLst>
              </a:tr>
              <a:tr h="4655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C reactive protei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5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54100024"/>
                  </a:ext>
                </a:extLst>
              </a:tr>
              <a:tr h="4655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Erythrocyte sedimentation rat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83185860"/>
                  </a:ext>
                </a:extLst>
              </a:tr>
              <a:tr h="4655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Ferrit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9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69405835"/>
                  </a:ext>
                </a:extLst>
              </a:tr>
              <a:tr h="4655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Lactate dehydrogena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657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U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05450698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Google Shape;97;p2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Urinalysis</a:t>
            </a:r>
            <a:endParaRPr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422C25E-0568-0437-E94A-C23B6E3FDE9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7783195"/>
              </p:ext>
            </p:extLst>
          </p:nvPr>
        </p:nvGraphicFramePr>
        <p:xfrm>
          <a:off x="3041650" y="1171575"/>
          <a:ext cx="3060700" cy="28003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60500">
                  <a:extLst>
                    <a:ext uri="{9D8B030D-6E8A-4147-A177-3AD203B41FA5}">
                      <a16:colId xmlns:a16="http://schemas.microsoft.com/office/drawing/2014/main" val="3536856578"/>
                    </a:ext>
                  </a:extLst>
                </a:gridCol>
                <a:gridCol w="800100">
                  <a:extLst>
                    <a:ext uri="{9D8B030D-6E8A-4147-A177-3AD203B41FA5}">
                      <a16:colId xmlns:a16="http://schemas.microsoft.com/office/drawing/2014/main" val="3316609191"/>
                    </a:ext>
                  </a:extLst>
                </a:gridCol>
                <a:gridCol w="800100">
                  <a:extLst>
                    <a:ext uri="{9D8B030D-6E8A-4147-A177-3AD203B41FA5}">
                      <a16:colId xmlns:a16="http://schemas.microsoft.com/office/drawing/2014/main" val="2299261743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highlight>
                            <a:srgbClr val="B4C6E7"/>
                          </a:highlight>
                        </a:rPr>
                        <a:t>Laboratory Test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highlight>
                            <a:srgbClr val="B4C6E7"/>
                          </a:highlight>
                        </a:rPr>
                        <a:t>Valu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highlight>
                            <a:srgbClr val="B4C6E7"/>
                          </a:highlight>
                        </a:rPr>
                        <a:t>Units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7083554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H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2842609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Specific Gravit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.02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1811180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Gluco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Negativ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mg/d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5495965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rotei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gativ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mg/d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7980822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Bilirubi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mg/d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6575469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robilinoge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mg/d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0205819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Bloo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Trac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mg/d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5582613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Keton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gative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mg/d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7773126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Nitrit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Negativ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mg/d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0308708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eukocyte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Negativ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WBC/u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5660306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Ascorbic Aci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mg/dL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8908830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larity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lea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847570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olo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Clea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 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35393391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Google Shape;70;p1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Morning Labs (4am, ~12 hours ago)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AF89AA36-263A-BB4F-B93B-ED1663EBC0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086398"/>
              </p:ext>
            </p:extLst>
          </p:nvPr>
        </p:nvGraphicFramePr>
        <p:xfrm>
          <a:off x="311701" y="1017724"/>
          <a:ext cx="3741826" cy="250119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9911">
                  <a:extLst>
                    <a:ext uri="{9D8B030D-6E8A-4147-A177-3AD203B41FA5}">
                      <a16:colId xmlns:a16="http://schemas.microsoft.com/office/drawing/2014/main" val="2254030423"/>
                    </a:ext>
                  </a:extLst>
                </a:gridCol>
                <a:gridCol w="1321580">
                  <a:extLst>
                    <a:ext uri="{9D8B030D-6E8A-4147-A177-3AD203B41FA5}">
                      <a16:colId xmlns:a16="http://schemas.microsoft.com/office/drawing/2014/main" val="1417602540"/>
                    </a:ext>
                  </a:extLst>
                </a:gridCol>
                <a:gridCol w="1200335">
                  <a:extLst>
                    <a:ext uri="{9D8B030D-6E8A-4147-A177-3AD203B41FA5}">
                      <a16:colId xmlns:a16="http://schemas.microsoft.com/office/drawing/2014/main" val="3595192226"/>
                    </a:ext>
                  </a:extLst>
                </a:gridCol>
              </a:tblGrid>
              <a:tr h="3573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  <a:highlight>
                            <a:srgbClr val="B4C6E7"/>
                          </a:highlight>
                        </a:rPr>
                        <a:t>Laboratory Test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  <a:highlight>
                            <a:srgbClr val="B4C6E7"/>
                          </a:highlight>
                        </a:rPr>
                        <a:t>Value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u="none" strike="noStrike" dirty="0">
                          <a:effectLst/>
                          <a:highlight>
                            <a:srgbClr val="B4C6E7"/>
                          </a:highlight>
                        </a:rPr>
                        <a:t>Units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83913766"/>
                  </a:ext>
                </a:extLst>
              </a:tr>
              <a:tr h="3573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White blood cell coun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51.8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/mm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52203584"/>
                  </a:ext>
                </a:extLst>
              </a:tr>
              <a:tr h="3573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Hemoglobin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7.5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g/dl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46625066"/>
                  </a:ext>
                </a:extLst>
              </a:tr>
              <a:tr h="3573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Hematocri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2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%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68401820"/>
                  </a:ext>
                </a:extLst>
              </a:tr>
              <a:tr h="3573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Platelets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79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/mm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5462384"/>
                  </a:ext>
                </a:extLst>
              </a:tr>
              <a:tr h="3573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>
                          <a:effectLst/>
                        </a:rPr>
                        <a:t>Mean corpuscular volum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80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 err="1">
                          <a:effectLst/>
                        </a:rPr>
                        <a:t>fL</a:t>
                      </a:r>
                      <a:r>
                        <a:rPr lang="en-US" sz="1050" u="none" strike="noStrike" dirty="0">
                          <a:effectLst/>
                        </a:rPr>
                        <a:t>/red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99330403"/>
                  </a:ext>
                </a:extLst>
              </a:tr>
              <a:tr h="3573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Blasts 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68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u="none" strike="noStrike" dirty="0">
                          <a:effectLst/>
                        </a:rPr>
                        <a:t>%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06592224"/>
                  </a:ext>
                </a:extLst>
              </a:tr>
            </a:tbl>
          </a:graphicData>
        </a:graphic>
      </p:graphicFrame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15A06EB-54F2-87F6-04AC-D1440D8A52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5718343"/>
              </p:ext>
            </p:extLst>
          </p:nvPr>
        </p:nvGraphicFramePr>
        <p:xfrm>
          <a:off x="4703972" y="1017724"/>
          <a:ext cx="3741827" cy="406021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83174">
                  <a:extLst>
                    <a:ext uri="{9D8B030D-6E8A-4147-A177-3AD203B41FA5}">
                      <a16:colId xmlns:a16="http://schemas.microsoft.com/office/drawing/2014/main" val="1769827520"/>
                    </a:ext>
                  </a:extLst>
                </a:gridCol>
                <a:gridCol w="1180499">
                  <a:extLst>
                    <a:ext uri="{9D8B030D-6E8A-4147-A177-3AD203B41FA5}">
                      <a16:colId xmlns:a16="http://schemas.microsoft.com/office/drawing/2014/main" val="3757846763"/>
                    </a:ext>
                  </a:extLst>
                </a:gridCol>
                <a:gridCol w="978154">
                  <a:extLst>
                    <a:ext uri="{9D8B030D-6E8A-4147-A177-3AD203B41FA5}">
                      <a16:colId xmlns:a16="http://schemas.microsoft.com/office/drawing/2014/main" val="726549189"/>
                    </a:ext>
                  </a:extLst>
                </a:gridCol>
              </a:tblGrid>
              <a:tr h="32617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Laboratory Tes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Valu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highlight>
                            <a:srgbClr val="B4C6E7"/>
                          </a:highlight>
                        </a:rPr>
                        <a:t>Unit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highlight>
                          <a:srgbClr val="B4C6E7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58912849"/>
                  </a:ext>
                </a:extLst>
              </a:tr>
              <a:tr h="24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Sodiu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4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18626887"/>
                  </a:ext>
                </a:extLst>
              </a:tr>
              <a:tr h="23305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Potassiu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95544149"/>
                  </a:ext>
                </a:extLst>
              </a:tr>
              <a:tr h="24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Chlorid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83024514"/>
                  </a:ext>
                </a:extLst>
              </a:tr>
              <a:tr h="24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Bicarbonat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21668105"/>
                  </a:ext>
                </a:extLst>
              </a:tr>
              <a:tr h="24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Blood urea nitrogen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18776917"/>
                  </a:ext>
                </a:extLst>
              </a:tr>
              <a:tr h="24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Creatini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47122930"/>
                  </a:ext>
                </a:extLst>
              </a:tr>
              <a:tr h="24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Gluco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3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 err="1">
                          <a:effectLst/>
                        </a:rPr>
                        <a:t>mEq</a:t>
                      </a:r>
                      <a:r>
                        <a:rPr lang="en-US" sz="1200" u="none" strike="noStrike" dirty="0">
                          <a:effectLst/>
                        </a:rPr>
                        <a:t>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11741758"/>
                  </a:ext>
                </a:extLst>
              </a:tr>
              <a:tr h="24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Prote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7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g/d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78821447"/>
                  </a:ext>
                </a:extLst>
              </a:tr>
              <a:tr h="24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Album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g/d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67845300"/>
                  </a:ext>
                </a:extLst>
              </a:tr>
              <a:tr h="24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Total Bilirub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0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mg/d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61494583"/>
                  </a:ext>
                </a:extLst>
              </a:tr>
              <a:tr h="24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Aspartate aminotransfera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5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U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22235217"/>
                  </a:ext>
                </a:extLst>
              </a:tr>
              <a:tr h="24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</a:rPr>
                        <a:t>Alanine aminotransferas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5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U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95555695"/>
                  </a:ext>
                </a:extLst>
              </a:tr>
              <a:tr h="3041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Alkaline Phosphata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U/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63185481"/>
                  </a:ext>
                </a:extLst>
              </a:tr>
              <a:tr h="24462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</a:rPr>
                        <a:t>Uric Aci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rgbClr val="FFCFB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mg/dL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5590043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1625006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C45D0D-FC5E-2FD2-61C4-13B31F2F90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5671" y="93669"/>
            <a:ext cx="8520600" cy="572700"/>
          </a:xfrm>
        </p:spPr>
        <p:txBody>
          <a:bodyPr>
            <a:normAutofit fontScale="90000"/>
          </a:bodyPr>
          <a:lstStyle/>
          <a:p>
            <a:r>
              <a:rPr lang="en-US"/>
              <a:t>Handoff</a:t>
            </a:r>
          </a:p>
        </p:txBody>
      </p:sp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19C79C52-8399-7AAB-3314-D351CBF86E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1208353"/>
              </p:ext>
            </p:extLst>
          </p:nvPr>
        </p:nvGraphicFramePr>
        <p:xfrm>
          <a:off x="311697" y="666369"/>
          <a:ext cx="8424409" cy="423511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31893">
                  <a:extLst>
                    <a:ext uri="{9D8B030D-6E8A-4147-A177-3AD203B41FA5}">
                      <a16:colId xmlns:a16="http://schemas.microsoft.com/office/drawing/2014/main" val="3026508190"/>
                    </a:ext>
                  </a:extLst>
                </a:gridCol>
                <a:gridCol w="1360965">
                  <a:extLst>
                    <a:ext uri="{9D8B030D-6E8A-4147-A177-3AD203B41FA5}">
                      <a16:colId xmlns:a16="http://schemas.microsoft.com/office/drawing/2014/main" val="1755101501"/>
                    </a:ext>
                  </a:extLst>
                </a:gridCol>
                <a:gridCol w="1395662">
                  <a:extLst>
                    <a:ext uri="{9D8B030D-6E8A-4147-A177-3AD203B41FA5}">
                      <a16:colId xmlns:a16="http://schemas.microsoft.com/office/drawing/2014/main" val="1859587757"/>
                    </a:ext>
                  </a:extLst>
                </a:gridCol>
                <a:gridCol w="1395663">
                  <a:extLst>
                    <a:ext uri="{9D8B030D-6E8A-4147-A177-3AD203B41FA5}">
                      <a16:colId xmlns:a16="http://schemas.microsoft.com/office/drawing/2014/main" val="3691229717"/>
                    </a:ext>
                  </a:extLst>
                </a:gridCol>
                <a:gridCol w="1006706">
                  <a:extLst>
                    <a:ext uri="{9D8B030D-6E8A-4147-A177-3AD203B41FA5}">
                      <a16:colId xmlns:a16="http://schemas.microsoft.com/office/drawing/2014/main" val="1536489506"/>
                    </a:ext>
                  </a:extLst>
                </a:gridCol>
                <a:gridCol w="1143000">
                  <a:extLst>
                    <a:ext uri="{9D8B030D-6E8A-4147-A177-3AD203B41FA5}">
                      <a16:colId xmlns:a16="http://schemas.microsoft.com/office/drawing/2014/main" val="3770054146"/>
                    </a:ext>
                  </a:extLst>
                </a:gridCol>
                <a:gridCol w="990520">
                  <a:extLst>
                    <a:ext uri="{9D8B030D-6E8A-4147-A177-3AD203B41FA5}">
                      <a16:colId xmlns:a16="http://schemas.microsoft.com/office/drawing/2014/main" val="1343103262"/>
                    </a:ext>
                  </a:extLst>
                </a:gridCol>
              </a:tblGrid>
              <a:tr h="4235115">
                <a:tc>
                  <a:txBody>
                    <a:bodyPr/>
                    <a:lstStyle/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</a:rPr>
                        <a:t>6 year old male with no past medical history presenting after nosebleed and found to have </a:t>
                      </a:r>
                      <a:r>
                        <a:rPr lang="en-US" sz="1000" b="0">
                          <a:solidFill>
                            <a:schemeClr val="tx1"/>
                          </a:solidFill>
                        </a:rPr>
                        <a:t>High risk B-cell Acute Lymphoblastic Leukemia </a:t>
                      </a:r>
                      <a:endParaRPr lang="en-US" sz="1000" b="0" dirty="0">
                        <a:solidFill>
                          <a:schemeClr val="tx1"/>
                        </a:solidFill>
                      </a:endParaRPr>
                    </a:p>
                    <a:p>
                      <a:endParaRPr lang="en-US" sz="1000" b="0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</a:rPr>
                        <a:t>-Induction therapy</a:t>
                      </a:r>
                    </a:p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</a:rPr>
                        <a:t>-Febrile neutropenia (last fever 1200 38.5)</a:t>
                      </a:r>
                    </a:p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</a:rPr>
                        <a:t>-Tumor lysis syndrome</a:t>
                      </a:r>
                    </a:p>
                    <a:p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1">
                          <a:solidFill>
                            <a:schemeClr val="tx1"/>
                          </a:solidFill>
                        </a:rPr>
                        <a:t>Cardiovascular</a:t>
                      </a:r>
                    </a:p>
                    <a:p>
                      <a:r>
                        <a:rPr lang="en-US" sz="1000" b="0">
                          <a:solidFill>
                            <a:schemeClr val="tx1"/>
                          </a:solidFill>
                        </a:rPr>
                        <a:t>-Room air</a:t>
                      </a:r>
                    </a:p>
                    <a:p>
                      <a:endParaRPr lang="en-US" sz="1000" b="0" dirty="0">
                        <a:solidFill>
                          <a:schemeClr val="tx1"/>
                        </a:solidFill>
                      </a:endParaRPr>
                    </a:p>
                    <a:p>
                      <a:endParaRPr lang="en-US" sz="1000" b="0">
                        <a:solidFill>
                          <a:schemeClr val="tx1"/>
                        </a:solidFill>
                      </a:endParaRPr>
                    </a:p>
                    <a:p>
                      <a:endParaRPr lang="en-US" sz="1000" b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</a:rPr>
                        <a:t>Echo normal</a:t>
                      </a:r>
                    </a:p>
                    <a:p>
                      <a:r>
                        <a:rPr lang="en-US" sz="1000" b="0">
                          <a:solidFill>
                            <a:schemeClr val="tx1"/>
                          </a:solidFill>
                        </a:rPr>
                        <a:t>Chest X-ray norm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1" dirty="0">
                          <a:solidFill>
                            <a:schemeClr val="tx1"/>
                          </a:solidFill>
                        </a:rPr>
                        <a:t>Nutrition and </a:t>
                      </a:r>
                      <a:r>
                        <a:rPr lang="en-US" sz="1000" b="1">
                          <a:solidFill>
                            <a:schemeClr val="tx1"/>
                          </a:solidFill>
                        </a:rPr>
                        <a:t>gastrointestial</a:t>
                      </a:r>
                      <a:endParaRPr lang="en-US" sz="1000" b="1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sz="1000" b="0">
                          <a:solidFill>
                            <a:schemeClr val="tx1"/>
                          </a:solidFill>
                        </a:rPr>
                        <a:t>-regular diet</a:t>
                      </a:r>
                    </a:p>
                    <a:p>
                      <a:pPr lvl="0">
                        <a:buNone/>
                      </a:pPr>
                      <a:r>
                        <a:rPr lang="en-US" sz="1000" b="0">
                          <a:solidFill>
                            <a:schemeClr val="tx1"/>
                          </a:solidFill>
                        </a:rPr>
                        <a:t>-intravenous fluids</a:t>
                      </a:r>
                      <a:endParaRPr lang="en-US" sz="1000" b="0" dirty="0">
                        <a:solidFill>
                          <a:schemeClr val="tx1"/>
                        </a:solidFill>
                      </a:endParaRPr>
                    </a:p>
                    <a:p>
                      <a:endParaRPr lang="en-US" sz="1000" b="0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sz="1000" b="0">
                          <a:solidFill>
                            <a:schemeClr val="tx1"/>
                          </a:solidFill>
                        </a:rPr>
                        <a:t>-Zofran as needed</a:t>
                      </a:r>
                    </a:p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</a:rPr>
                        <a:t>-Scopolamine </a:t>
                      </a:r>
                      <a:r>
                        <a:rPr lang="en-US" sz="1000" b="0">
                          <a:solidFill>
                            <a:schemeClr val="tx1"/>
                          </a:solidFill>
                        </a:rPr>
                        <a:t>patch evey 72 hours</a:t>
                      </a:r>
                    </a:p>
                    <a:p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1">
                          <a:solidFill>
                            <a:schemeClr val="tx1"/>
                          </a:solidFill>
                        </a:rPr>
                        <a:t>Oncology and Hematology</a:t>
                      </a:r>
                      <a:endParaRPr lang="en-US" sz="1000" b="1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</a:rPr>
                        <a:t>-Induction day 3 per protocol</a:t>
                      </a:r>
                    </a:p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</a:rPr>
                        <a:t>-Allopurinol </a:t>
                      </a:r>
                      <a:r>
                        <a:rPr lang="en-US" sz="1000" b="0">
                          <a:solidFill>
                            <a:schemeClr val="tx1"/>
                          </a:solidFill>
                        </a:rPr>
                        <a:t>three times per day</a:t>
                      </a:r>
                    </a:p>
                    <a:p>
                      <a:endParaRPr lang="en-US" sz="1000" b="0" dirty="0">
                        <a:solidFill>
                          <a:schemeClr val="tx1"/>
                        </a:solidFill>
                      </a:endParaRPr>
                    </a:p>
                    <a:p>
                      <a:endParaRPr lang="en-US" sz="1000" b="0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sz="1000" b="0" i="1" dirty="0">
                          <a:solidFill>
                            <a:schemeClr val="tx1"/>
                          </a:solidFill>
                        </a:rPr>
                        <a:t>Received afrin x1 in </a:t>
                      </a:r>
                      <a:r>
                        <a:rPr lang="en-US" sz="1000" b="0" i="1">
                          <a:solidFill>
                            <a:schemeClr val="tx1"/>
                          </a:solidFill>
                        </a:rPr>
                        <a:t>emergency room for nosebleed</a:t>
                      </a:r>
                      <a:endParaRPr lang="en-US" sz="1000" b="0" i="1" dirty="0">
                        <a:solidFill>
                          <a:schemeClr val="tx1"/>
                        </a:solidFill>
                      </a:endParaRPr>
                    </a:p>
                    <a:p>
                      <a:endParaRPr 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1">
                          <a:solidFill>
                            <a:schemeClr val="tx1"/>
                          </a:solidFill>
                        </a:rPr>
                        <a:t>Neurology</a:t>
                      </a:r>
                    </a:p>
                    <a:p>
                      <a:endParaRPr lang="en-US" sz="1000" b="0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sz="1000" b="0">
                          <a:solidFill>
                            <a:schemeClr val="tx1"/>
                          </a:solidFill>
                        </a:rPr>
                        <a:t>-Tylenol as needed</a:t>
                      </a:r>
                    </a:p>
                    <a:p>
                      <a:endParaRPr lang="en-US" sz="10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1">
                          <a:solidFill>
                            <a:schemeClr val="tx1"/>
                          </a:solidFill>
                        </a:rPr>
                        <a:t>Infectious disease</a:t>
                      </a:r>
                    </a:p>
                    <a:p>
                      <a:r>
                        <a:rPr lang="en-US" sz="1000" b="0">
                          <a:solidFill>
                            <a:schemeClr val="tx1"/>
                          </a:solidFill>
                        </a:rPr>
                        <a:t>-Cefepime every 8 hours</a:t>
                      </a:r>
                    </a:p>
                    <a:p>
                      <a:endParaRPr lang="en-US" sz="1000" b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sz="1000" b="0">
                          <a:solidFill>
                            <a:schemeClr val="tx1"/>
                          </a:solidFill>
                        </a:rPr>
                        <a:t>-Cultures from blood and urine pending</a:t>
                      </a:r>
                    </a:p>
                    <a:p>
                      <a:endParaRPr lang="en-US" sz="100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b="1">
                          <a:solidFill>
                            <a:schemeClr val="tx1"/>
                          </a:solidFill>
                        </a:rPr>
                        <a:t>PLAN</a:t>
                      </a:r>
                    </a:p>
                    <a:p>
                      <a:r>
                        <a:rPr lang="en-US" sz="1000" b="0" dirty="0">
                          <a:solidFill>
                            <a:schemeClr val="tx1"/>
                          </a:solidFill>
                        </a:rPr>
                        <a:t>-Consider escalation to vancomycin if clinically worsening </a:t>
                      </a:r>
                    </a:p>
                    <a:p>
                      <a:endParaRPr lang="en-US" sz="1000" b="0">
                        <a:solidFill>
                          <a:schemeClr val="tx1"/>
                        </a:solidFill>
                      </a:endParaRPr>
                    </a:p>
                    <a:p>
                      <a:endParaRPr lang="en-US" sz="1000" b="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56697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033395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4A9BAA-5DFC-B68B-A1AF-F88E264515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36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“That is a lot of bleeding, what could we give to treat this?”</a:t>
            </a:r>
            <a:br>
              <a:rPr lang="en-US" sz="3600" kern="100" dirty="0">
                <a:solidFill>
                  <a:srgbClr val="000000"/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920581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90340F-C136-F2AB-A252-AC798D276A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3600" kern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“What do you think is going on?”</a:t>
            </a:r>
            <a:br>
              <a:rPr lang="en-US" sz="3600" kern="100" dirty="0">
                <a:solidFill>
                  <a:srgbClr val="000000"/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84161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BE0510-D5C9-F225-2640-D3FD15B548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3600" kern="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“What else should we do?”</a:t>
            </a:r>
            <a:br>
              <a:rPr lang="en-US" sz="3600" kern="100" dirty="0">
                <a:solidFill>
                  <a:srgbClr val="000000"/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459582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EFC7B9-7B87-4A81-1A0E-D09035A7BE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“Look! He is starting to bleed from his eyes now”</a:t>
            </a: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141661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802949-2D9B-762D-482F-E42EA3A8D8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36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“This patient is bleeding from everywhere! I saw some bleeding from his central access as well when we drew labs. What do you think is going on and what should we do next?”</a:t>
            </a:r>
            <a:br>
              <a:rPr lang="en-US" sz="3600" kern="100" dirty="0">
                <a:solidFill>
                  <a:srgbClr val="000000"/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86730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63CFAC-CB19-EDAA-8668-E86C61A0F9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36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“That oxygen level is awfully low. Should we do something about it?”</a:t>
            </a:r>
            <a:br>
              <a:rPr lang="en-US" sz="3600" kern="100" dirty="0">
                <a:solidFill>
                  <a:srgbClr val="000000"/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56178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0C8932-1D3B-8156-BCF1-7E6532DA88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“He just had a huge vomit of blood! He is having a hard time talking to us and is gasping for air”</a:t>
            </a: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23422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A4A362-C83F-5DCC-E691-0E6F230A01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36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“I am worried about his airway with all of the bleeding. What should we do?”</a:t>
            </a:r>
            <a:br>
              <a:rPr lang="en-US" sz="3600" kern="100" dirty="0">
                <a:solidFill>
                  <a:srgbClr val="000000"/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96225256"/>
      </p:ext>
    </p:extLst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755</Words>
  <Application>Microsoft Office PowerPoint</Application>
  <PresentationFormat>On-screen Show (16:9)</PresentationFormat>
  <Paragraphs>333</Paragraphs>
  <Slides>18</Slides>
  <Notes>9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19" baseType="lpstr">
      <vt:lpstr>Simple Light</vt:lpstr>
      <vt:lpstr>Labs, Imaging, Prompts</vt:lpstr>
      <vt:lpstr>“That is a lot of bleeding, what could we give to treat this?” </vt:lpstr>
      <vt:lpstr>“What do you think is going on?” </vt:lpstr>
      <vt:lpstr>“What else should we do?” </vt:lpstr>
      <vt:lpstr>“Look! He is starting to bleed from his eyes now” </vt:lpstr>
      <vt:lpstr>“This patient is bleeding from everywhere! I saw some bleeding from his central access as well when we drew labs. What do you think is going on and what should we do next?” </vt:lpstr>
      <vt:lpstr>“That oxygen level is awfully low. Should we do something about it?” </vt:lpstr>
      <vt:lpstr>“He just had a huge vomit of blood! He is having a hard time talking to us and is gasping for air” </vt:lpstr>
      <vt:lpstr>“I am worried about his airway with all of the bleeding. What should we do?” </vt:lpstr>
      <vt:lpstr>Point of Care (POC)- Glucose</vt:lpstr>
      <vt:lpstr>Venous Blood Gas</vt:lpstr>
      <vt:lpstr>Complete Blood Count </vt:lpstr>
      <vt:lpstr>Coagulation Labs</vt:lpstr>
      <vt:lpstr>Comprehensive Metabolic Profile</vt:lpstr>
      <vt:lpstr>Inflammatory Markers</vt:lpstr>
      <vt:lpstr>Urinalysis</vt:lpstr>
      <vt:lpstr>Morning Labs (4am, ~12 hours ago) </vt:lpstr>
      <vt:lpstr>Handoff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Walter, Kimberly</cp:lastModifiedBy>
  <cp:revision>81</cp:revision>
  <dcterms:modified xsi:type="dcterms:W3CDTF">2025-09-09T22:21:22Z</dcterms:modified>
</cp:coreProperties>
</file>